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00" d="100"/>
          <a:sy n="100" d="100"/>
        </p:scale>
        <p:origin x="1176" y="-3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3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6" Type="http://schemas.openxmlformats.org/officeDocument/2006/relationships/image" Target="../media/image16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5" Type="http://schemas.openxmlformats.org/officeDocument/2006/relationships/image" Target="../media/image1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Relationship Id="rId14" Type="http://schemas.openxmlformats.org/officeDocument/2006/relationships/image" Target="../media/image1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 smtClean="0"/>
              <a:t>Kattintson ide az alcím mintájának szerkesztéséhez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C0454-1F1D-474C-B093-6D08DF41518D}" type="datetimeFigureOut">
              <a:rPr lang="hu-HU" smtClean="0"/>
              <a:t>2017. 07. 1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209A-E6BF-449C-9EBE-AD58DD1B740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498362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C0454-1F1D-474C-B093-6D08DF41518D}" type="datetimeFigureOut">
              <a:rPr lang="hu-HU" smtClean="0"/>
              <a:t>2017. 07. 1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209A-E6BF-449C-9EBE-AD58DD1B740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80830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C0454-1F1D-474C-B093-6D08DF41518D}" type="datetimeFigureOut">
              <a:rPr lang="hu-HU" smtClean="0"/>
              <a:t>2017. 07. 1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209A-E6BF-449C-9EBE-AD58DD1B740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806191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C0454-1F1D-474C-B093-6D08DF41518D}" type="datetimeFigureOut">
              <a:rPr lang="hu-HU" smtClean="0"/>
              <a:t>2017. 07. 1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209A-E6BF-449C-9EBE-AD58DD1B740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84186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C0454-1F1D-474C-B093-6D08DF41518D}" type="datetimeFigureOut">
              <a:rPr lang="hu-HU" smtClean="0"/>
              <a:t>2017. 07. 1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209A-E6BF-449C-9EBE-AD58DD1B740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703129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C0454-1F1D-474C-B093-6D08DF41518D}" type="datetimeFigureOut">
              <a:rPr lang="hu-HU" smtClean="0"/>
              <a:t>2017. 07. 17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209A-E6BF-449C-9EBE-AD58DD1B740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043702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C0454-1F1D-474C-B093-6D08DF41518D}" type="datetimeFigureOut">
              <a:rPr lang="hu-HU" smtClean="0"/>
              <a:t>2017. 07. 17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209A-E6BF-449C-9EBE-AD58DD1B740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907538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C0454-1F1D-474C-B093-6D08DF41518D}" type="datetimeFigureOut">
              <a:rPr lang="hu-HU" smtClean="0"/>
              <a:t>2017. 07. 17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209A-E6BF-449C-9EBE-AD58DD1B740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94335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C0454-1F1D-474C-B093-6D08DF41518D}" type="datetimeFigureOut">
              <a:rPr lang="hu-HU" smtClean="0"/>
              <a:t>2017. 07. 17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209A-E6BF-449C-9EBE-AD58DD1B740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361280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C0454-1F1D-474C-B093-6D08DF41518D}" type="datetimeFigureOut">
              <a:rPr lang="hu-HU" smtClean="0"/>
              <a:t>2017. 07. 17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209A-E6BF-449C-9EBE-AD58DD1B740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446527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 smtClean="0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C0454-1F1D-474C-B093-6D08DF41518D}" type="datetimeFigureOut">
              <a:rPr lang="hu-HU" smtClean="0"/>
              <a:t>2017. 07. 17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8209A-E6BF-449C-9EBE-AD58DD1B740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021281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7C0454-1F1D-474C-B093-6D08DF41518D}" type="datetimeFigureOut">
              <a:rPr lang="hu-HU" smtClean="0"/>
              <a:t>2017. 07. 17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88209A-E6BF-449C-9EBE-AD58DD1B7406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2935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26" Type="http://schemas.openxmlformats.org/officeDocument/2006/relationships/image" Target="../media/image12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34" Type="http://schemas.openxmlformats.org/officeDocument/2006/relationships/image" Target="../media/image16.emf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33" Type="http://schemas.openxmlformats.org/officeDocument/2006/relationships/oleObject" Target="../embeddings/oleObject16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29" Type="http://schemas.openxmlformats.org/officeDocument/2006/relationships/oleObject" Target="../embeddings/oleObject14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32" Type="http://schemas.openxmlformats.org/officeDocument/2006/relationships/image" Target="../media/image15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28" Type="http://schemas.openxmlformats.org/officeDocument/2006/relationships/image" Target="../media/image13.emf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31" Type="http://schemas.openxmlformats.org/officeDocument/2006/relationships/oleObject" Target="../embeddings/oleObject15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Relationship Id="rId27" Type="http://schemas.openxmlformats.org/officeDocument/2006/relationships/oleObject" Target="../embeddings/oleObject13.bin"/><Relationship Id="rId30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/>
          <p:cNvSpPr txBox="1"/>
          <p:nvPr/>
        </p:nvSpPr>
        <p:spPr>
          <a:xfrm>
            <a:off x="1580403" y="89196"/>
            <a:ext cx="39407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b="1" dirty="0" err="1" smtClean="0"/>
              <a:t>Diterpene</a:t>
            </a:r>
            <a:r>
              <a:rPr lang="hu-HU" b="1" dirty="0" smtClean="0"/>
              <a:t> </a:t>
            </a:r>
            <a:r>
              <a:rPr lang="hu-HU" b="1" dirty="0" err="1" smtClean="0"/>
              <a:t>alkaloids</a:t>
            </a:r>
            <a:r>
              <a:rPr lang="hu-HU" b="1" dirty="0" smtClean="0"/>
              <a:t> </a:t>
            </a:r>
            <a:r>
              <a:rPr lang="hu-HU" b="1" dirty="0" err="1" smtClean="0"/>
              <a:t>from</a:t>
            </a:r>
            <a:r>
              <a:rPr lang="hu-HU" b="1" dirty="0" smtClean="0"/>
              <a:t> </a:t>
            </a:r>
            <a:r>
              <a:rPr lang="hu-HU" b="1" i="1" dirty="0" err="1" smtClean="0"/>
              <a:t>Spiraea</a:t>
            </a:r>
            <a:r>
              <a:rPr lang="hu-HU" b="1" i="1" dirty="0" smtClean="0"/>
              <a:t> </a:t>
            </a:r>
            <a:r>
              <a:rPr lang="hu-HU" b="1" dirty="0" smtClean="0"/>
              <a:t>genus</a:t>
            </a:r>
            <a:endParaRPr lang="hu-HU" b="1" dirty="0"/>
          </a:p>
        </p:txBody>
      </p:sp>
      <p:graphicFrame>
        <p:nvGraphicFramePr>
          <p:cNvPr id="5" name="Objektum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16623122"/>
              </p:ext>
            </p:extLst>
          </p:nvPr>
        </p:nvGraphicFramePr>
        <p:xfrm>
          <a:off x="234637" y="453673"/>
          <a:ext cx="746125" cy="722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CS ChemDraw Drawing" r:id="rId3" imgW="1238707" imgH="1203614" progId="ChemDraw.Document.6.0">
                  <p:embed/>
                </p:oleObj>
              </mc:Choice>
              <mc:Fallback>
                <p:oleObj name="CS ChemDraw Drawing" r:id="rId3" imgW="1238707" imgH="1203614" progId="ChemDraw.Document.6.0">
                  <p:embed/>
                  <p:pic>
                    <p:nvPicPr>
                      <p:cNvPr id="5" name="Objektum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34637" y="453673"/>
                        <a:ext cx="746125" cy="722312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églalap 5"/>
          <p:cNvSpPr/>
          <p:nvPr/>
        </p:nvSpPr>
        <p:spPr>
          <a:xfrm>
            <a:off x="0" y="1189935"/>
            <a:ext cx="126669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sz="800" dirty="0" err="1" smtClean="0">
                <a:ea typeface="Calibri" panose="020F0502020204030204" pitchFamily="34" charset="0"/>
              </a:rPr>
              <a:t>spiramine</a:t>
            </a:r>
            <a:r>
              <a:rPr lang="hu-HU" sz="800" dirty="0" smtClean="0">
                <a:ea typeface="Calibri" panose="020F0502020204030204" pitchFamily="34" charset="0"/>
              </a:rPr>
              <a:t> </a:t>
            </a:r>
            <a:r>
              <a:rPr lang="hu-HU" sz="800" dirty="0">
                <a:ea typeface="Calibri" panose="020F0502020204030204" pitchFamily="34" charset="0"/>
              </a:rPr>
              <a:t>Z-2 (</a:t>
            </a:r>
            <a:r>
              <a:rPr lang="hu-HU" sz="800" b="1" dirty="0">
                <a:ea typeface="Calibri" panose="020F0502020204030204" pitchFamily="34" charset="0"/>
              </a:rPr>
              <a:t>1</a:t>
            </a:r>
            <a:r>
              <a:rPr lang="hu-HU" sz="800" dirty="0">
                <a:ea typeface="Calibri" panose="020F0502020204030204" pitchFamily="34" charset="0"/>
              </a:rPr>
              <a:t>) (R = </a:t>
            </a:r>
            <a:r>
              <a:rPr lang="hu-HU" sz="800" dirty="0" smtClean="0">
                <a:ea typeface="Calibri" panose="020F0502020204030204" pitchFamily="34" charset="0"/>
              </a:rPr>
              <a:t>α-H)</a:t>
            </a:r>
          </a:p>
          <a:p>
            <a:r>
              <a:rPr lang="hu-HU" sz="800" dirty="0" err="1" smtClean="0">
                <a:ea typeface="Calibri" panose="020F0502020204030204" pitchFamily="34" charset="0"/>
              </a:rPr>
              <a:t>spiramine</a:t>
            </a:r>
            <a:r>
              <a:rPr lang="hu-HU" sz="800" dirty="0" smtClean="0">
                <a:ea typeface="Calibri" panose="020F0502020204030204" pitchFamily="34" charset="0"/>
              </a:rPr>
              <a:t> </a:t>
            </a:r>
            <a:r>
              <a:rPr lang="hu-HU" sz="800" dirty="0">
                <a:ea typeface="Calibri" panose="020F0502020204030204" pitchFamily="34" charset="0"/>
              </a:rPr>
              <a:t>Z-3 (</a:t>
            </a:r>
            <a:r>
              <a:rPr lang="hu-HU" sz="800" b="1" dirty="0">
                <a:ea typeface="Calibri" panose="020F0502020204030204" pitchFamily="34" charset="0"/>
              </a:rPr>
              <a:t>2</a:t>
            </a:r>
            <a:r>
              <a:rPr lang="hu-HU" sz="800" dirty="0">
                <a:ea typeface="Calibri" panose="020F0502020204030204" pitchFamily="34" charset="0"/>
              </a:rPr>
              <a:t>) (R = β-H)</a:t>
            </a:r>
            <a:endParaRPr lang="hu-HU" sz="800" dirty="0"/>
          </a:p>
        </p:txBody>
      </p:sp>
      <p:graphicFrame>
        <p:nvGraphicFramePr>
          <p:cNvPr id="7" name="Objektum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0374455"/>
              </p:ext>
            </p:extLst>
          </p:nvPr>
        </p:nvGraphicFramePr>
        <p:xfrm>
          <a:off x="2383039" y="489951"/>
          <a:ext cx="750887" cy="660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CS ChemDraw Drawing" r:id="rId5" imgW="1252323" imgH="1096903" progId="ChemDraw.Document.6.0">
                  <p:embed/>
                </p:oleObj>
              </mc:Choice>
              <mc:Fallback>
                <p:oleObj name="CS ChemDraw Drawing" r:id="rId5" imgW="1252323" imgH="1096903" progId="ChemDraw.Document.6.0">
                  <p:embed/>
                  <p:pic>
                    <p:nvPicPr>
                      <p:cNvPr id="8" name="Objektum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383039" y="489951"/>
                        <a:ext cx="750887" cy="6604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Táblázat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18224832"/>
              </p:ext>
            </p:extLst>
          </p:nvPr>
        </p:nvGraphicFramePr>
        <p:xfrm>
          <a:off x="1433714" y="1194226"/>
          <a:ext cx="2528897" cy="60960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142999">
                  <a:extLst>
                    <a:ext uri="{9D8B030D-6E8A-4147-A177-3AD203B41FA5}">
                      <a16:colId xmlns:a16="http://schemas.microsoft.com/office/drawing/2014/main" val="2031093096"/>
                    </a:ext>
                  </a:extLst>
                </a:gridCol>
                <a:gridCol w="404361">
                  <a:extLst>
                    <a:ext uri="{9D8B030D-6E8A-4147-A177-3AD203B41FA5}">
                      <a16:colId xmlns:a16="http://schemas.microsoft.com/office/drawing/2014/main" val="419453369"/>
                    </a:ext>
                  </a:extLst>
                </a:gridCol>
                <a:gridCol w="549661">
                  <a:extLst>
                    <a:ext uri="{9D8B030D-6E8A-4147-A177-3AD203B41FA5}">
                      <a16:colId xmlns:a16="http://schemas.microsoft.com/office/drawing/2014/main" val="4013007477"/>
                    </a:ext>
                  </a:extLst>
                </a:gridCol>
                <a:gridCol w="431876">
                  <a:extLst>
                    <a:ext uri="{9D8B030D-6E8A-4147-A177-3AD203B41FA5}">
                      <a16:colId xmlns:a16="http://schemas.microsoft.com/office/drawing/2014/main" val="15448188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 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1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2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3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74836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deacetyl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S (</a:t>
                      </a:r>
                      <a:r>
                        <a:rPr lang="hu-HU" sz="800" b="1" dirty="0">
                          <a:effectLst/>
                        </a:rPr>
                        <a:t>3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H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α-OH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522552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d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(</a:t>
                      </a:r>
                      <a:r>
                        <a:rPr lang="hu-HU" sz="800" b="1" dirty="0">
                          <a:effectLst/>
                        </a:rPr>
                        <a:t>4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β-</a:t>
                      </a:r>
                      <a:r>
                        <a:rPr lang="hu-HU" sz="800" dirty="0" err="1">
                          <a:effectLst/>
                        </a:rPr>
                        <a:t>OAc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α-</a:t>
                      </a:r>
                      <a:r>
                        <a:rPr lang="hu-HU" sz="800" dirty="0" err="1">
                          <a:effectLst/>
                        </a:rPr>
                        <a:t>OAc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493391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S (</a:t>
                      </a:r>
                      <a:r>
                        <a:rPr lang="hu-HU" sz="800" b="1" dirty="0">
                          <a:effectLst/>
                        </a:rPr>
                        <a:t>5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α-OH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24218270"/>
                  </a:ext>
                </a:extLst>
              </a:tr>
              <a:tr h="5080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V (</a:t>
                      </a:r>
                      <a:r>
                        <a:rPr lang="hu-HU" sz="800" b="1" dirty="0">
                          <a:effectLst/>
                        </a:rPr>
                        <a:t>6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α-OH, </a:t>
                      </a:r>
                      <a:r>
                        <a:rPr lang="hu-HU" sz="800" dirty="0" err="1">
                          <a:effectLst/>
                        </a:rPr>
                        <a:t>Ac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α-OH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24108613"/>
                  </a:ext>
                </a:extLst>
              </a:tr>
            </a:tbl>
          </a:graphicData>
        </a:graphic>
      </p:graphicFrame>
      <p:graphicFrame>
        <p:nvGraphicFramePr>
          <p:cNvPr id="9" name="Objektum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3394127"/>
              </p:ext>
            </p:extLst>
          </p:nvPr>
        </p:nvGraphicFramePr>
        <p:xfrm>
          <a:off x="5024757" y="505438"/>
          <a:ext cx="785813" cy="603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CS ChemDraw Drawing" r:id="rId7" imgW="1308680" imgH="1008291" progId="ChemDraw.Document.6.0">
                  <p:embed/>
                </p:oleObj>
              </mc:Choice>
              <mc:Fallback>
                <p:oleObj name="CS ChemDraw Drawing" r:id="rId7" imgW="1308680" imgH="1008291" progId="ChemDraw.Document.6.0">
                  <p:embed/>
                  <p:pic>
                    <p:nvPicPr>
                      <p:cNvPr id="14" name="Objektum 1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024757" y="505438"/>
                        <a:ext cx="785813" cy="6032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Táblázat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60589196"/>
              </p:ext>
            </p:extLst>
          </p:nvPr>
        </p:nvGraphicFramePr>
        <p:xfrm>
          <a:off x="4310381" y="1111884"/>
          <a:ext cx="2214563" cy="60960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785813">
                  <a:extLst>
                    <a:ext uri="{9D8B030D-6E8A-4147-A177-3AD203B41FA5}">
                      <a16:colId xmlns:a16="http://schemas.microsoft.com/office/drawing/2014/main" val="69059489"/>
                    </a:ext>
                  </a:extLst>
                </a:gridCol>
                <a:gridCol w="361950">
                  <a:extLst>
                    <a:ext uri="{9D8B030D-6E8A-4147-A177-3AD203B41FA5}">
                      <a16:colId xmlns:a16="http://schemas.microsoft.com/office/drawing/2014/main" val="3600409288"/>
                    </a:ext>
                  </a:extLst>
                </a:gridCol>
                <a:gridCol w="385762">
                  <a:extLst>
                    <a:ext uri="{9D8B030D-6E8A-4147-A177-3AD203B41FA5}">
                      <a16:colId xmlns:a16="http://schemas.microsoft.com/office/drawing/2014/main" val="1574129599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3916843462"/>
                    </a:ext>
                  </a:extLst>
                </a:gridCol>
                <a:gridCol w="261938">
                  <a:extLst>
                    <a:ext uri="{9D8B030D-6E8A-4147-A177-3AD203B41FA5}">
                      <a16:colId xmlns:a16="http://schemas.microsoft.com/office/drawing/2014/main" val="124941397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 </a:t>
                      </a:r>
                      <a:endParaRPr lang="hu-HU" sz="8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1</a:t>
                      </a:r>
                      <a:endParaRPr lang="hu-HU" sz="8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2</a:t>
                      </a:r>
                      <a:endParaRPr lang="hu-HU" sz="8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3</a:t>
                      </a:r>
                      <a:endParaRPr lang="hu-HU" sz="8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4</a:t>
                      </a:r>
                      <a:endParaRPr lang="hu-HU" sz="8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914350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G (</a:t>
                      </a:r>
                      <a:r>
                        <a:rPr lang="hu-HU" sz="800" b="1" dirty="0">
                          <a:effectLst/>
                        </a:rPr>
                        <a:t>7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OH</a:t>
                      </a:r>
                      <a:endParaRPr lang="hu-HU" sz="8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=O</a:t>
                      </a:r>
                      <a:endParaRPr lang="hu-HU" sz="8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476672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H (</a:t>
                      </a:r>
                      <a:r>
                        <a:rPr lang="hu-HU" sz="800" b="1" dirty="0">
                          <a:effectLst/>
                        </a:rPr>
                        <a:t>8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OH</a:t>
                      </a:r>
                      <a:endParaRPr lang="hu-HU" sz="8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=O</a:t>
                      </a:r>
                      <a:endParaRPr lang="hu-HU" sz="8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699981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I (</a:t>
                      </a:r>
                      <a:r>
                        <a:rPr lang="hu-HU" sz="800" b="1" dirty="0">
                          <a:effectLst/>
                        </a:rPr>
                        <a:t>9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OH</a:t>
                      </a:r>
                      <a:endParaRPr lang="hu-HU" sz="8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Ac</a:t>
                      </a:r>
                      <a:endParaRPr lang="hu-HU" sz="8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=O</a:t>
                      </a:r>
                      <a:endParaRPr lang="hu-HU" sz="8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811444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t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A (</a:t>
                      </a:r>
                      <a:r>
                        <a:rPr lang="hu-HU" sz="800" b="1" dirty="0">
                          <a:effectLst/>
                        </a:rPr>
                        <a:t>10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=O</a:t>
                      </a:r>
                      <a:endParaRPr lang="hu-HU" sz="8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α-OH</a:t>
                      </a:r>
                      <a:endParaRPr lang="hu-HU" sz="8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H</a:t>
                      </a:r>
                      <a:endParaRPr lang="hu-HU" sz="8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00776556"/>
                  </a:ext>
                </a:extLst>
              </a:tr>
            </a:tbl>
          </a:graphicData>
        </a:graphic>
      </p:graphicFrame>
      <p:graphicFrame>
        <p:nvGraphicFramePr>
          <p:cNvPr id="11" name="Objektum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6912051"/>
              </p:ext>
            </p:extLst>
          </p:nvPr>
        </p:nvGraphicFramePr>
        <p:xfrm>
          <a:off x="685900" y="2069404"/>
          <a:ext cx="795337" cy="76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CS ChemDraw Drawing" r:id="rId9" imgW="1322674" imgH="1257159" progId="ChemDraw.Document.6.0">
                  <p:embed/>
                </p:oleObj>
              </mc:Choice>
              <mc:Fallback>
                <p:oleObj name="CS ChemDraw Drawing" r:id="rId9" imgW="1322674" imgH="1257159" progId="ChemDraw.Document.6.0">
                  <p:embed/>
                  <p:pic>
                    <p:nvPicPr>
                      <p:cNvPr id="17" name="Objektum 1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85900" y="2069404"/>
                        <a:ext cx="795337" cy="760413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Táblázat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3276087"/>
              </p:ext>
            </p:extLst>
          </p:nvPr>
        </p:nvGraphicFramePr>
        <p:xfrm>
          <a:off x="3033" y="2791875"/>
          <a:ext cx="1962154" cy="85344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838199">
                  <a:extLst>
                    <a:ext uri="{9D8B030D-6E8A-4147-A177-3AD203B41FA5}">
                      <a16:colId xmlns:a16="http://schemas.microsoft.com/office/drawing/2014/main" val="4262897226"/>
                    </a:ext>
                  </a:extLst>
                </a:gridCol>
                <a:gridCol w="414337">
                  <a:extLst>
                    <a:ext uri="{9D8B030D-6E8A-4147-A177-3AD203B41FA5}">
                      <a16:colId xmlns:a16="http://schemas.microsoft.com/office/drawing/2014/main" val="3255776845"/>
                    </a:ext>
                  </a:extLst>
                </a:gridCol>
                <a:gridCol w="404813">
                  <a:extLst>
                    <a:ext uri="{9D8B030D-6E8A-4147-A177-3AD203B41FA5}">
                      <a16:colId xmlns:a16="http://schemas.microsoft.com/office/drawing/2014/main" val="1169171481"/>
                    </a:ext>
                  </a:extLst>
                </a:gridCol>
                <a:gridCol w="304805">
                  <a:extLst>
                    <a:ext uri="{9D8B030D-6E8A-4147-A177-3AD203B41FA5}">
                      <a16:colId xmlns:a16="http://schemas.microsoft.com/office/drawing/2014/main" val="192510431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 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>
                          <a:effectLst/>
                        </a:rPr>
                        <a:t>R</a:t>
                      </a:r>
                      <a:r>
                        <a:rPr lang="hu-HU" sz="800" b="1" baseline="-25000">
                          <a:effectLst/>
                        </a:rPr>
                        <a:t>1</a:t>
                      </a:r>
                      <a:endParaRPr lang="hu-HU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2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3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088050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d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F (</a:t>
                      </a:r>
                      <a:r>
                        <a:rPr lang="hu-HU" sz="800" b="1" dirty="0">
                          <a:effectLst/>
                        </a:rPr>
                        <a:t>11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187839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d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G (</a:t>
                      </a:r>
                      <a:r>
                        <a:rPr lang="hu-HU" sz="800" b="1" dirty="0">
                          <a:effectLst/>
                        </a:rPr>
                        <a:t>12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586723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A (</a:t>
                      </a:r>
                      <a:r>
                        <a:rPr lang="hu-HU" sz="800" b="1" dirty="0">
                          <a:effectLst/>
                        </a:rPr>
                        <a:t>13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177437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B (</a:t>
                      </a:r>
                      <a:r>
                        <a:rPr lang="hu-HU" sz="800" b="1" dirty="0">
                          <a:effectLst/>
                        </a:rPr>
                        <a:t>14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838775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C (</a:t>
                      </a:r>
                      <a:r>
                        <a:rPr lang="hu-HU" sz="800" b="1" dirty="0">
                          <a:effectLst/>
                        </a:rPr>
                        <a:t>15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043650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D (</a:t>
                      </a:r>
                      <a:r>
                        <a:rPr lang="hu-HU" sz="800" b="1" dirty="0">
                          <a:effectLst/>
                        </a:rPr>
                        <a:t>16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α-H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41976771"/>
                  </a:ext>
                </a:extLst>
              </a:tr>
            </a:tbl>
          </a:graphicData>
        </a:graphic>
      </p:graphicFrame>
      <p:graphicFrame>
        <p:nvGraphicFramePr>
          <p:cNvPr id="13" name="Objektum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90295827"/>
              </p:ext>
            </p:extLst>
          </p:nvPr>
        </p:nvGraphicFramePr>
        <p:xfrm>
          <a:off x="2808491" y="2036602"/>
          <a:ext cx="777875" cy="658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CS ChemDraw Drawing" r:id="rId11" imgW="1293550" imgH="1096903" progId="ChemDraw.Document.6.0">
                  <p:embed/>
                </p:oleObj>
              </mc:Choice>
              <mc:Fallback>
                <p:oleObj name="CS ChemDraw Drawing" r:id="rId11" imgW="1293550" imgH="1096903" progId="ChemDraw.Document.6.0">
                  <p:embed/>
                  <p:pic>
                    <p:nvPicPr>
                      <p:cNvPr id="20" name="Objektum 1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808491" y="2036602"/>
                        <a:ext cx="777875" cy="658813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Táblázat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71039562"/>
              </p:ext>
            </p:extLst>
          </p:nvPr>
        </p:nvGraphicFramePr>
        <p:xfrm>
          <a:off x="1901159" y="2762090"/>
          <a:ext cx="2444910" cy="73152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847885">
                  <a:extLst>
                    <a:ext uri="{9D8B030D-6E8A-4147-A177-3AD203B41FA5}">
                      <a16:colId xmlns:a16="http://schemas.microsoft.com/office/drawing/2014/main" val="1905609925"/>
                    </a:ext>
                  </a:extLst>
                </a:gridCol>
                <a:gridCol w="425450">
                  <a:extLst>
                    <a:ext uri="{9D8B030D-6E8A-4147-A177-3AD203B41FA5}">
                      <a16:colId xmlns:a16="http://schemas.microsoft.com/office/drawing/2014/main" val="3990172862"/>
                    </a:ext>
                  </a:extLst>
                </a:gridCol>
                <a:gridCol w="441325">
                  <a:extLst>
                    <a:ext uri="{9D8B030D-6E8A-4147-A177-3AD203B41FA5}">
                      <a16:colId xmlns:a16="http://schemas.microsoft.com/office/drawing/2014/main" val="2547295744"/>
                    </a:ext>
                  </a:extLst>
                </a:gridCol>
                <a:gridCol w="387350">
                  <a:extLst>
                    <a:ext uri="{9D8B030D-6E8A-4147-A177-3AD203B41FA5}">
                      <a16:colId xmlns:a16="http://schemas.microsoft.com/office/drawing/2014/main" val="121855726"/>
                    </a:ext>
                  </a:extLst>
                </a:gridCol>
                <a:gridCol w="342900">
                  <a:extLst>
                    <a:ext uri="{9D8B030D-6E8A-4147-A177-3AD203B41FA5}">
                      <a16:colId xmlns:a16="http://schemas.microsoft.com/office/drawing/2014/main" val="411779265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 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1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2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3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4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114931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P (</a:t>
                      </a:r>
                      <a:r>
                        <a:rPr lang="hu-HU" sz="800" b="1" dirty="0">
                          <a:effectLst/>
                        </a:rPr>
                        <a:t>17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 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Me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213354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Q (</a:t>
                      </a:r>
                      <a:r>
                        <a:rPr lang="hu-HU" sz="800" b="1" dirty="0">
                          <a:effectLst/>
                        </a:rPr>
                        <a:t>18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 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 Me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182932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T (</a:t>
                      </a:r>
                      <a:r>
                        <a:rPr lang="hu-HU" sz="800" b="1" dirty="0">
                          <a:effectLst/>
                        </a:rPr>
                        <a:t>19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 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 Me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453496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U (</a:t>
                      </a:r>
                      <a:r>
                        <a:rPr lang="hu-HU" sz="800" b="1" dirty="0">
                          <a:effectLst/>
                        </a:rPr>
                        <a:t>20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 O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 Me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056852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W (</a:t>
                      </a:r>
                      <a:r>
                        <a:rPr lang="hu-HU" sz="800" b="1" dirty="0">
                          <a:effectLst/>
                        </a:rPr>
                        <a:t>21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β- OH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 Me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β-H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8986282"/>
                  </a:ext>
                </a:extLst>
              </a:tr>
            </a:tbl>
          </a:graphicData>
        </a:graphic>
      </p:graphicFrame>
      <p:graphicFrame>
        <p:nvGraphicFramePr>
          <p:cNvPr id="15" name="Objektum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1687754"/>
              </p:ext>
            </p:extLst>
          </p:nvPr>
        </p:nvGraphicFramePr>
        <p:xfrm>
          <a:off x="5178670" y="2020923"/>
          <a:ext cx="788987" cy="660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CS ChemDraw Drawing" r:id="rId13" imgW="1312084" imgH="1098411" progId="ChemDraw.Document.6.0">
                  <p:embed/>
                </p:oleObj>
              </mc:Choice>
              <mc:Fallback>
                <p:oleObj name="CS ChemDraw Drawing" r:id="rId13" imgW="1312084" imgH="1098411" progId="ChemDraw.Document.6.0">
                  <p:embed/>
                  <p:pic>
                    <p:nvPicPr>
                      <p:cNvPr id="23" name="Objektum 2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178670" y="2020923"/>
                        <a:ext cx="788987" cy="6604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Táblázat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3887186"/>
              </p:ext>
            </p:extLst>
          </p:nvPr>
        </p:nvGraphicFramePr>
        <p:xfrm>
          <a:off x="4288328" y="2706407"/>
          <a:ext cx="2569672" cy="127895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134572">
                  <a:extLst>
                    <a:ext uri="{9D8B030D-6E8A-4147-A177-3AD203B41FA5}">
                      <a16:colId xmlns:a16="http://schemas.microsoft.com/office/drawing/2014/main" val="3575387833"/>
                    </a:ext>
                  </a:extLst>
                </a:gridCol>
                <a:gridCol w="387350">
                  <a:extLst>
                    <a:ext uri="{9D8B030D-6E8A-4147-A177-3AD203B41FA5}">
                      <a16:colId xmlns:a16="http://schemas.microsoft.com/office/drawing/2014/main" val="1044485005"/>
                    </a:ext>
                  </a:extLst>
                </a:gridCol>
                <a:gridCol w="450850">
                  <a:extLst>
                    <a:ext uri="{9D8B030D-6E8A-4147-A177-3AD203B41FA5}">
                      <a16:colId xmlns:a16="http://schemas.microsoft.com/office/drawing/2014/main" val="3627958133"/>
                    </a:ext>
                  </a:extLst>
                </a:gridCol>
                <a:gridCol w="234950">
                  <a:extLst>
                    <a:ext uri="{9D8B030D-6E8A-4147-A177-3AD203B41FA5}">
                      <a16:colId xmlns:a16="http://schemas.microsoft.com/office/drawing/2014/main" val="839420457"/>
                    </a:ext>
                  </a:extLst>
                </a:gridCol>
                <a:gridCol w="361950">
                  <a:extLst>
                    <a:ext uri="{9D8B030D-6E8A-4147-A177-3AD203B41FA5}">
                      <a16:colId xmlns:a16="http://schemas.microsoft.com/office/drawing/2014/main" val="2702424095"/>
                    </a:ext>
                  </a:extLst>
                </a:gridCol>
              </a:tblGrid>
              <a:tr h="127895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 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1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2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3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4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3110854781"/>
                  </a:ext>
                </a:extLst>
              </a:tr>
              <a:tr h="127895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deacetyl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F (</a:t>
                      </a:r>
                      <a:r>
                        <a:rPr lang="hu-HU" sz="800" b="1" dirty="0">
                          <a:effectLst/>
                        </a:rPr>
                        <a:t>22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1532120096"/>
                  </a:ext>
                </a:extLst>
              </a:tr>
              <a:tr h="127895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ea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A (</a:t>
                      </a:r>
                      <a:r>
                        <a:rPr lang="hu-HU" sz="800" b="1" dirty="0">
                          <a:effectLst/>
                        </a:rPr>
                        <a:t>23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3252788142"/>
                  </a:ext>
                </a:extLst>
              </a:tr>
              <a:tr h="127895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lactam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A (</a:t>
                      </a:r>
                      <a:r>
                        <a:rPr lang="hu-HU" sz="800" b="1" dirty="0">
                          <a:effectLst/>
                        </a:rPr>
                        <a:t>24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=O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2222750488"/>
                  </a:ext>
                </a:extLst>
              </a:tr>
              <a:tr h="127895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lactam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B (</a:t>
                      </a:r>
                      <a:r>
                        <a:rPr lang="hu-HU" sz="800" b="1" dirty="0">
                          <a:effectLst/>
                        </a:rPr>
                        <a:t>25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=O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2338671693"/>
                  </a:ext>
                </a:extLst>
              </a:tr>
              <a:tr h="127895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E (</a:t>
                      </a:r>
                      <a:r>
                        <a:rPr lang="hu-HU" sz="800" b="1" dirty="0">
                          <a:effectLst/>
                        </a:rPr>
                        <a:t>26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α-</a:t>
                      </a:r>
                      <a:r>
                        <a:rPr lang="hu-HU" sz="800" dirty="0" err="1">
                          <a:effectLst/>
                        </a:rPr>
                        <a:t>OAc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O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4164460107"/>
                  </a:ext>
                </a:extLst>
              </a:tr>
              <a:tr h="127895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0" dirty="0" err="1" smtClean="0">
                          <a:effectLst/>
                        </a:rPr>
                        <a:t>spiramine</a:t>
                      </a:r>
                      <a:r>
                        <a:rPr lang="hu-HU" sz="800" b="0" dirty="0" smtClean="0">
                          <a:effectLst/>
                        </a:rPr>
                        <a:t> </a:t>
                      </a:r>
                      <a:r>
                        <a:rPr lang="hu-HU" sz="800" b="0" dirty="0">
                          <a:effectLst/>
                        </a:rPr>
                        <a:t>F (</a:t>
                      </a:r>
                      <a:r>
                        <a:rPr lang="hu-HU" sz="800" b="1" dirty="0">
                          <a:effectLst/>
                        </a:rPr>
                        <a:t>27</a:t>
                      </a:r>
                      <a:r>
                        <a:rPr lang="hu-HU" sz="800" b="0" dirty="0">
                          <a:effectLst/>
                        </a:rPr>
                        <a:t>)</a:t>
                      </a:r>
                      <a:endParaRPr lang="hu-HU" sz="8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73557496"/>
                  </a:ext>
                </a:extLst>
              </a:tr>
              <a:tr h="127895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0" dirty="0" err="1" smtClean="0">
                          <a:effectLst/>
                        </a:rPr>
                        <a:t>spiramine</a:t>
                      </a:r>
                      <a:r>
                        <a:rPr lang="hu-HU" sz="800" b="0" dirty="0" smtClean="0">
                          <a:effectLst/>
                        </a:rPr>
                        <a:t> </a:t>
                      </a:r>
                      <a:r>
                        <a:rPr lang="hu-HU" sz="800" b="0" dirty="0">
                          <a:effectLst/>
                        </a:rPr>
                        <a:t>R (</a:t>
                      </a:r>
                      <a:r>
                        <a:rPr lang="hu-HU" sz="800" b="1" dirty="0">
                          <a:effectLst/>
                        </a:rPr>
                        <a:t>28</a:t>
                      </a:r>
                      <a:r>
                        <a:rPr lang="hu-HU" sz="800" b="0" dirty="0">
                          <a:effectLst/>
                        </a:rPr>
                        <a:t>) </a:t>
                      </a:r>
                      <a:endParaRPr lang="hu-HU" sz="8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=O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3696552679"/>
                  </a:ext>
                </a:extLst>
              </a:tr>
              <a:tr h="127895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X (</a:t>
                      </a:r>
                      <a:r>
                        <a:rPr lang="hu-HU" sz="800" b="1" dirty="0">
                          <a:effectLst/>
                        </a:rPr>
                        <a:t>29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=O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O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3994768434"/>
                  </a:ext>
                </a:extLst>
              </a:tr>
              <a:tr h="127895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Y (</a:t>
                      </a:r>
                      <a:r>
                        <a:rPr lang="hu-HU" sz="800" b="1" dirty="0">
                          <a:effectLst/>
                        </a:rPr>
                        <a:t>30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β-</a:t>
                      </a:r>
                      <a:r>
                        <a:rPr lang="hu-HU" sz="800" dirty="0" err="1">
                          <a:effectLst/>
                        </a:rPr>
                        <a:t>OAc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=O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OH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1197325719"/>
                  </a:ext>
                </a:extLst>
              </a:tr>
            </a:tbl>
          </a:graphicData>
        </a:graphic>
      </p:graphicFrame>
      <p:graphicFrame>
        <p:nvGraphicFramePr>
          <p:cNvPr id="17" name="Objektum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66327040"/>
              </p:ext>
            </p:extLst>
          </p:nvPr>
        </p:nvGraphicFramePr>
        <p:xfrm>
          <a:off x="114326" y="3748661"/>
          <a:ext cx="758825" cy="619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CS ChemDraw Drawing" r:id="rId15" imgW="1263292" imgH="1046752" progId="ChemDraw.Document.6.0">
                  <p:embed/>
                </p:oleObj>
              </mc:Choice>
              <mc:Fallback>
                <p:oleObj name="CS ChemDraw Drawing" r:id="rId15" imgW="1263292" imgH="1046752" progId="ChemDraw.Document.6.0">
                  <p:embed/>
                  <p:pic>
                    <p:nvPicPr>
                      <p:cNvPr id="26" name="Objektum 2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4326" y="3748661"/>
                        <a:ext cx="758825" cy="6191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églalap 17"/>
          <p:cNvSpPr/>
          <p:nvPr/>
        </p:nvSpPr>
        <p:spPr>
          <a:xfrm>
            <a:off x="0" y="4384552"/>
            <a:ext cx="95731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Aft>
                <a:spcPts val="0"/>
              </a:spcAft>
            </a:pPr>
            <a:r>
              <a:rPr lang="hu-HU" sz="800" dirty="0" err="1" smtClean="0">
                <a:ea typeface="Calibri" panose="020F0502020204030204" pitchFamily="34" charset="0"/>
                <a:cs typeface="Times New Roman" panose="02020603050405020304" pitchFamily="18" charset="0"/>
              </a:rPr>
              <a:t>spiramine</a:t>
            </a:r>
            <a:r>
              <a:rPr lang="hu-HU" sz="8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hu-HU" sz="800" dirty="0">
                <a:ea typeface="Calibri" panose="020F0502020204030204" pitchFamily="34" charset="0"/>
                <a:cs typeface="Times New Roman" panose="02020603050405020304" pitchFamily="18" charset="0"/>
              </a:rPr>
              <a:t>N-6 (</a:t>
            </a:r>
            <a:r>
              <a:rPr lang="hu-HU" sz="800" b="1" dirty="0">
                <a:ea typeface="Calibri" panose="020F0502020204030204" pitchFamily="34" charset="0"/>
                <a:cs typeface="Times New Roman" panose="02020603050405020304" pitchFamily="18" charset="0"/>
              </a:rPr>
              <a:t>31</a:t>
            </a:r>
            <a:r>
              <a:rPr lang="hu-HU" sz="800" dirty="0"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</a:p>
        </p:txBody>
      </p:sp>
      <p:graphicFrame>
        <p:nvGraphicFramePr>
          <p:cNvPr id="19" name="Objektum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9024449"/>
              </p:ext>
            </p:extLst>
          </p:nvPr>
        </p:nvGraphicFramePr>
        <p:xfrm>
          <a:off x="25777" y="4595993"/>
          <a:ext cx="738188" cy="644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CS ChemDraw Drawing" r:id="rId17" imgW="1229629" imgH="1070885" progId="ChemDraw.Document.6.0">
                  <p:embed/>
                </p:oleObj>
              </mc:Choice>
              <mc:Fallback>
                <p:oleObj name="CS ChemDraw Drawing" r:id="rId17" imgW="1229629" imgH="1070885" progId="ChemDraw.Document.6.0">
                  <p:embed/>
                  <p:pic>
                    <p:nvPicPr>
                      <p:cNvPr id="32" name="Objektum 3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777" y="4595993"/>
                        <a:ext cx="738188" cy="6445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églalap 19"/>
          <p:cNvSpPr/>
          <p:nvPr/>
        </p:nvSpPr>
        <p:spPr>
          <a:xfrm>
            <a:off x="-989" y="5241214"/>
            <a:ext cx="79220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Aft>
                <a:spcPts val="0"/>
              </a:spcAft>
            </a:pPr>
            <a:r>
              <a:rPr lang="hu-HU" sz="800" dirty="0" err="1" smtClean="0">
                <a:ea typeface="Calibri" panose="020F0502020204030204" pitchFamily="34" charset="0"/>
                <a:cs typeface="Times New Roman" panose="02020603050405020304" pitchFamily="18" charset="0"/>
              </a:rPr>
              <a:t>spirasine</a:t>
            </a:r>
            <a:r>
              <a:rPr lang="hu-HU" sz="8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 I </a:t>
            </a:r>
            <a:r>
              <a:rPr lang="hu-HU" sz="800" dirty="0"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hu-HU" sz="800" b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36</a:t>
            </a:r>
            <a:r>
              <a:rPr lang="hu-HU" sz="8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hu-HU" sz="8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21" name="Objektum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9757520"/>
              </p:ext>
            </p:extLst>
          </p:nvPr>
        </p:nvGraphicFramePr>
        <p:xfrm>
          <a:off x="1156835" y="3765431"/>
          <a:ext cx="736600" cy="639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CS ChemDraw Drawing" r:id="rId19" imgW="1238707" imgH="1071262" progId="ChemDraw.Document.6.0">
                  <p:embed/>
                </p:oleObj>
              </mc:Choice>
              <mc:Fallback>
                <p:oleObj name="CS ChemDraw Drawing" r:id="rId19" imgW="1238707" imgH="1071262" progId="ChemDraw.Document.6.0">
                  <p:embed/>
                  <p:pic>
                    <p:nvPicPr>
                      <p:cNvPr id="29" name="Objektum 2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56835" y="3765431"/>
                        <a:ext cx="736600" cy="639762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Táblázat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92057242"/>
              </p:ext>
            </p:extLst>
          </p:nvPr>
        </p:nvGraphicFramePr>
        <p:xfrm>
          <a:off x="864436" y="4497423"/>
          <a:ext cx="1518603" cy="60960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826453">
                  <a:extLst>
                    <a:ext uri="{9D8B030D-6E8A-4147-A177-3AD203B41FA5}">
                      <a16:colId xmlns:a16="http://schemas.microsoft.com/office/drawing/2014/main" val="1092591596"/>
                    </a:ext>
                  </a:extLst>
                </a:gridCol>
                <a:gridCol w="393700">
                  <a:extLst>
                    <a:ext uri="{9D8B030D-6E8A-4147-A177-3AD203B41FA5}">
                      <a16:colId xmlns:a16="http://schemas.microsoft.com/office/drawing/2014/main" val="3750112400"/>
                    </a:ext>
                  </a:extLst>
                </a:gridCol>
                <a:gridCol w="298450">
                  <a:extLst>
                    <a:ext uri="{9D8B030D-6E8A-4147-A177-3AD203B41FA5}">
                      <a16:colId xmlns:a16="http://schemas.microsoft.com/office/drawing/2014/main" val="72716814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 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1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2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525054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d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D (</a:t>
                      </a:r>
                      <a:r>
                        <a:rPr lang="hu-HU" sz="800" b="1" dirty="0">
                          <a:effectLst/>
                        </a:rPr>
                        <a:t>32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681264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s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II (</a:t>
                      </a:r>
                      <a:r>
                        <a:rPr lang="hu-HU" sz="800" b="1" dirty="0">
                          <a:effectLst/>
                        </a:rPr>
                        <a:t>33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474908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s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III (</a:t>
                      </a:r>
                      <a:r>
                        <a:rPr lang="hu-HU" sz="800" b="1" dirty="0">
                          <a:effectLst/>
                        </a:rPr>
                        <a:t>34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=O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87450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ed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(</a:t>
                      </a:r>
                      <a:r>
                        <a:rPr lang="hu-HU" sz="800" b="1" dirty="0">
                          <a:effectLst/>
                        </a:rPr>
                        <a:t>35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H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=O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17237391"/>
                  </a:ext>
                </a:extLst>
              </a:tr>
            </a:tbl>
          </a:graphicData>
        </a:graphic>
      </p:graphicFrame>
      <p:graphicFrame>
        <p:nvGraphicFramePr>
          <p:cNvPr id="23" name="Objektum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1968286"/>
              </p:ext>
            </p:extLst>
          </p:nvPr>
        </p:nvGraphicFramePr>
        <p:xfrm>
          <a:off x="3264007" y="4129611"/>
          <a:ext cx="777875" cy="644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CS ChemDraw Drawing" r:id="rId21" imgW="1293550" imgH="1071262" progId="ChemDraw.Document.6.0">
                  <p:embed/>
                </p:oleObj>
              </mc:Choice>
              <mc:Fallback>
                <p:oleObj name="CS ChemDraw Drawing" r:id="rId21" imgW="1293550" imgH="1071262" progId="ChemDraw.Document.6.0">
                  <p:embed/>
                  <p:pic>
                    <p:nvPicPr>
                      <p:cNvPr id="35" name="Objektum 3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64007" y="4129611"/>
                        <a:ext cx="777875" cy="6445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Táblázat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34169003"/>
              </p:ext>
            </p:extLst>
          </p:nvPr>
        </p:nvGraphicFramePr>
        <p:xfrm>
          <a:off x="2422801" y="4821064"/>
          <a:ext cx="2344346" cy="60960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849016">
                  <a:extLst>
                    <a:ext uri="{9D8B030D-6E8A-4147-A177-3AD203B41FA5}">
                      <a16:colId xmlns:a16="http://schemas.microsoft.com/office/drawing/2014/main" val="3958610711"/>
                    </a:ext>
                  </a:extLst>
                </a:gridCol>
                <a:gridCol w="390430">
                  <a:extLst>
                    <a:ext uri="{9D8B030D-6E8A-4147-A177-3AD203B41FA5}">
                      <a16:colId xmlns:a16="http://schemas.microsoft.com/office/drawing/2014/main" val="2374664946"/>
                    </a:ext>
                  </a:extLst>
                </a:gridCol>
                <a:gridCol w="247650">
                  <a:extLst>
                    <a:ext uri="{9D8B030D-6E8A-4147-A177-3AD203B41FA5}">
                      <a16:colId xmlns:a16="http://schemas.microsoft.com/office/drawing/2014/main" val="2225956300"/>
                    </a:ext>
                  </a:extLst>
                </a:gridCol>
                <a:gridCol w="412750">
                  <a:extLst>
                    <a:ext uri="{9D8B030D-6E8A-4147-A177-3AD203B41FA5}">
                      <a16:colId xmlns:a16="http://schemas.microsoft.com/office/drawing/2014/main" val="3349551905"/>
                    </a:ext>
                  </a:extLst>
                </a:gridCol>
                <a:gridCol w="444500">
                  <a:extLst>
                    <a:ext uri="{9D8B030D-6E8A-4147-A177-3AD203B41FA5}">
                      <a16:colId xmlns:a16="http://schemas.microsoft.com/office/drawing/2014/main" val="215854413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 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1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2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3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4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144116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s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V (</a:t>
                      </a:r>
                      <a:r>
                        <a:rPr lang="hu-HU" sz="800" b="1" dirty="0">
                          <a:effectLst/>
                        </a:rPr>
                        <a:t>37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CH</a:t>
                      </a:r>
                      <a:r>
                        <a:rPr lang="hu-HU" sz="800" baseline="-25000">
                          <a:effectLst/>
                        </a:rPr>
                        <a:t>3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058821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s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VI (</a:t>
                      </a:r>
                      <a:r>
                        <a:rPr lang="hu-HU" sz="800" b="1" dirty="0">
                          <a:effectLst/>
                        </a:rPr>
                        <a:t>38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α- CH</a:t>
                      </a:r>
                      <a:r>
                        <a:rPr lang="hu-HU" sz="800" baseline="-25000" dirty="0">
                          <a:effectLst/>
                        </a:rPr>
                        <a:t>3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510203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s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VII (</a:t>
                      </a:r>
                      <a:r>
                        <a:rPr lang="hu-HU" sz="800" b="1" dirty="0">
                          <a:effectLst/>
                        </a:rPr>
                        <a:t>39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CH</a:t>
                      </a:r>
                      <a:r>
                        <a:rPr lang="hu-HU" sz="800" baseline="-25000">
                          <a:effectLst/>
                        </a:rPr>
                        <a:t>3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785625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s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VIII (</a:t>
                      </a:r>
                      <a:r>
                        <a:rPr lang="hu-HU" sz="800" b="1" dirty="0">
                          <a:effectLst/>
                        </a:rPr>
                        <a:t>40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α- CH</a:t>
                      </a:r>
                      <a:r>
                        <a:rPr lang="hu-HU" sz="800" baseline="-25000" dirty="0">
                          <a:effectLst/>
                        </a:rPr>
                        <a:t>3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β-OH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31861103"/>
                  </a:ext>
                </a:extLst>
              </a:tr>
            </a:tbl>
          </a:graphicData>
        </a:graphic>
      </p:graphicFrame>
      <p:graphicFrame>
        <p:nvGraphicFramePr>
          <p:cNvPr id="25" name="Objektum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3691265"/>
              </p:ext>
            </p:extLst>
          </p:nvPr>
        </p:nvGraphicFramePr>
        <p:xfrm>
          <a:off x="4878315" y="4192422"/>
          <a:ext cx="730250" cy="644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CS ChemDraw Drawing" r:id="rId23" imgW="1215635" imgH="1071262" progId="ChemDraw.Document.6.0">
                  <p:embed/>
                </p:oleObj>
              </mc:Choice>
              <mc:Fallback>
                <p:oleObj name="CS ChemDraw Drawing" r:id="rId23" imgW="1215635" imgH="1071262" progId="ChemDraw.Document.6.0">
                  <p:embed/>
                  <p:pic>
                    <p:nvPicPr>
                      <p:cNvPr id="40" name="Objektum 3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878315" y="4192422"/>
                        <a:ext cx="730250" cy="6445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ktum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58046838"/>
              </p:ext>
            </p:extLst>
          </p:nvPr>
        </p:nvGraphicFramePr>
        <p:xfrm>
          <a:off x="5990275" y="4129611"/>
          <a:ext cx="735012" cy="639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CS ChemDraw Drawing" r:id="rId25" imgW="1224712" imgH="1070885" progId="ChemDraw.Document.6.0">
                  <p:embed/>
                </p:oleObj>
              </mc:Choice>
              <mc:Fallback>
                <p:oleObj name="CS ChemDraw Drawing" r:id="rId25" imgW="1224712" imgH="1070885" progId="ChemDraw.Document.6.0">
                  <p:embed/>
                  <p:pic>
                    <p:nvPicPr>
                      <p:cNvPr id="42" name="Objektum 4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990275" y="4129611"/>
                        <a:ext cx="735012" cy="639762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Téglalap 26"/>
          <p:cNvSpPr/>
          <p:nvPr/>
        </p:nvSpPr>
        <p:spPr>
          <a:xfrm>
            <a:off x="4838521" y="4836947"/>
            <a:ext cx="80983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Aft>
                <a:spcPts val="0"/>
              </a:spcAft>
            </a:pPr>
            <a:r>
              <a:rPr lang="hu-HU" sz="800" dirty="0" err="1" smtClean="0">
                <a:ea typeface="Calibri" panose="020F0502020204030204" pitchFamily="34" charset="0"/>
                <a:cs typeface="Times New Roman" panose="02020603050405020304" pitchFamily="18" charset="0"/>
              </a:rPr>
              <a:t>spirafine</a:t>
            </a:r>
            <a:r>
              <a:rPr lang="hu-HU" sz="8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 II (</a:t>
            </a:r>
            <a:r>
              <a:rPr lang="hu-HU" sz="800" b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41</a:t>
            </a:r>
            <a:r>
              <a:rPr lang="hu-HU" sz="800" dirty="0"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8" name="Téglalap 27"/>
          <p:cNvSpPr/>
          <p:nvPr/>
        </p:nvSpPr>
        <p:spPr>
          <a:xfrm>
            <a:off x="5940037" y="4836947"/>
            <a:ext cx="83548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Aft>
                <a:spcPts val="0"/>
              </a:spcAft>
            </a:pPr>
            <a:r>
              <a:rPr lang="hu-HU" sz="800" dirty="0" err="1" smtClean="0">
                <a:ea typeface="Calibri" panose="020F0502020204030204" pitchFamily="34" charset="0"/>
                <a:cs typeface="Times New Roman" panose="02020603050405020304" pitchFamily="18" charset="0"/>
              </a:rPr>
              <a:t>spirafine</a:t>
            </a:r>
            <a:r>
              <a:rPr lang="hu-HU" sz="8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 III (</a:t>
            </a:r>
            <a:r>
              <a:rPr lang="hu-HU" sz="800" b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42</a:t>
            </a:r>
            <a:r>
              <a:rPr lang="hu-HU" sz="8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hu-HU" sz="8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29" name="Objektum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62387169"/>
              </p:ext>
            </p:extLst>
          </p:nvPr>
        </p:nvGraphicFramePr>
        <p:xfrm>
          <a:off x="1175932" y="5629725"/>
          <a:ext cx="803275" cy="658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" name="CS ChemDraw Drawing" r:id="rId27" imgW="1340829" imgH="1096903" progId="ChemDraw.Document.6.0">
                  <p:embed/>
                </p:oleObj>
              </mc:Choice>
              <mc:Fallback>
                <p:oleObj name="CS ChemDraw Drawing" r:id="rId27" imgW="1340829" imgH="1096903" progId="ChemDraw.Document.6.0">
                  <p:embed/>
                  <p:pic>
                    <p:nvPicPr>
                      <p:cNvPr id="38" name="Objektum 3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75932" y="5629725"/>
                        <a:ext cx="803275" cy="658812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Táblázat 2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62856370"/>
              </p:ext>
            </p:extLst>
          </p:nvPr>
        </p:nvGraphicFramePr>
        <p:xfrm>
          <a:off x="21215" y="6315209"/>
          <a:ext cx="3112711" cy="150729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341061">
                  <a:extLst>
                    <a:ext uri="{9D8B030D-6E8A-4147-A177-3AD203B41FA5}">
                      <a16:colId xmlns:a16="http://schemas.microsoft.com/office/drawing/2014/main" val="10883260"/>
                    </a:ext>
                  </a:extLst>
                </a:gridCol>
                <a:gridCol w="400050">
                  <a:extLst>
                    <a:ext uri="{9D8B030D-6E8A-4147-A177-3AD203B41FA5}">
                      <a16:colId xmlns:a16="http://schemas.microsoft.com/office/drawing/2014/main" val="195296677"/>
                    </a:ext>
                  </a:extLst>
                </a:gridCol>
                <a:gridCol w="444500">
                  <a:extLst>
                    <a:ext uri="{9D8B030D-6E8A-4147-A177-3AD203B41FA5}">
                      <a16:colId xmlns:a16="http://schemas.microsoft.com/office/drawing/2014/main" val="1138029075"/>
                    </a:ext>
                  </a:extLst>
                </a:gridCol>
                <a:gridCol w="381000">
                  <a:extLst>
                    <a:ext uri="{9D8B030D-6E8A-4147-A177-3AD203B41FA5}">
                      <a16:colId xmlns:a16="http://schemas.microsoft.com/office/drawing/2014/main" val="4137179838"/>
                    </a:ext>
                  </a:extLst>
                </a:gridCol>
                <a:gridCol w="546100">
                  <a:extLst>
                    <a:ext uri="{9D8B030D-6E8A-4147-A177-3AD203B41FA5}">
                      <a16:colId xmlns:a16="http://schemas.microsoft.com/office/drawing/2014/main" val="2612294961"/>
                    </a:ext>
                  </a:extLst>
                </a:gridCol>
              </a:tblGrid>
              <a:tr h="150729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 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1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2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3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4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580894513"/>
                  </a:ext>
                </a:extLst>
              </a:tr>
              <a:tr h="150729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smtClean="0">
                          <a:effectLst/>
                        </a:rPr>
                        <a:t>19-</a:t>
                      </a:r>
                      <a:r>
                        <a:rPr lang="hu-HU" sz="800" i="1" dirty="0" smtClean="0">
                          <a:effectLst/>
                        </a:rPr>
                        <a:t>O</a:t>
                      </a:r>
                      <a:r>
                        <a:rPr lang="hu-HU" sz="800" dirty="0" smtClean="0">
                          <a:effectLst/>
                        </a:rPr>
                        <a:t>-deethylspiramine </a:t>
                      </a:r>
                      <a:r>
                        <a:rPr lang="hu-HU" sz="800" dirty="0">
                          <a:effectLst/>
                        </a:rPr>
                        <a:t>N (</a:t>
                      </a:r>
                      <a:r>
                        <a:rPr lang="hu-HU" sz="800" b="1" dirty="0">
                          <a:effectLst/>
                        </a:rPr>
                        <a:t>43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α-OH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α-OH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308919180"/>
                  </a:ext>
                </a:extLst>
              </a:tr>
              <a:tr h="150729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J (</a:t>
                      </a:r>
                      <a:r>
                        <a:rPr lang="hu-HU" sz="800" b="1" dirty="0">
                          <a:effectLst/>
                        </a:rPr>
                        <a:t>44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CH</a:t>
                      </a:r>
                      <a:r>
                        <a:rPr lang="hu-HU" sz="800" baseline="-25000">
                          <a:effectLst/>
                        </a:rPr>
                        <a:t>2</a:t>
                      </a:r>
                      <a:r>
                        <a:rPr lang="hu-HU" sz="800">
                          <a:effectLst/>
                        </a:rPr>
                        <a:t>-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3409014433"/>
                  </a:ext>
                </a:extLst>
              </a:tr>
              <a:tr h="150729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K (</a:t>
                      </a:r>
                      <a:r>
                        <a:rPr lang="hu-HU" sz="800" b="1" dirty="0">
                          <a:effectLst/>
                        </a:rPr>
                        <a:t>45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CH</a:t>
                      </a:r>
                      <a:r>
                        <a:rPr lang="hu-HU" sz="800" baseline="-25000">
                          <a:effectLst/>
                        </a:rPr>
                        <a:t>2</a:t>
                      </a:r>
                      <a:r>
                        <a:rPr lang="hu-HU" sz="800">
                          <a:effectLst/>
                        </a:rPr>
                        <a:t>-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3545964186"/>
                  </a:ext>
                </a:extLst>
              </a:tr>
              <a:tr h="150729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L (</a:t>
                      </a:r>
                      <a:r>
                        <a:rPr lang="hu-HU" sz="800" b="1" dirty="0">
                          <a:effectLst/>
                        </a:rPr>
                        <a:t>46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CH</a:t>
                      </a:r>
                      <a:r>
                        <a:rPr lang="hu-HU" sz="800" baseline="-25000">
                          <a:effectLst/>
                        </a:rPr>
                        <a:t>2</a:t>
                      </a:r>
                      <a:r>
                        <a:rPr lang="hu-HU" sz="800">
                          <a:effectLst/>
                        </a:rPr>
                        <a:t>-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1704085847"/>
                  </a:ext>
                </a:extLst>
              </a:tr>
              <a:tr h="150729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M (</a:t>
                      </a:r>
                      <a:r>
                        <a:rPr lang="hu-HU" sz="800" b="1" dirty="0">
                          <a:effectLst/>
                        </a:rPr>
                        <a:t>47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CH</a:t>
                      </a:r>
                      <a:r>
                        <a:rPr lang="hu-HU" sz="800" baseline="-25000">
                          <a:effectLst/>
                        </a:rPr>
                        <a:t>2</a:t>
                      </a:r>
                      <a:r>
                        <a:rPr lang="hu-HU" sz="800">
                          <a:effectLst/>
                        </a:rPr>
                        <a:t>-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646964043"/>
                  </a:ext>
                </a:extLst>
              </a:tr>
              <a:tr h="150729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N (</a:t>
                      </a:r>
                      <a:r>
                        <a:rPr lang="hu-HU" sz="800" b="1" dirty="0">
                          <a:effectLst/>
                        </a:rPr>
                        <a:t>48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Et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159569401"/>
                  </a:ext>
                </a:extLst>
              </a:tr>
              <a:tr h="150729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O (</a:t>
                      </a:r>
                      <a:r>
                        <a:rPr lang="hu-HU" sz="800" b="1" dirty="0">
                          <a:effectLst/>
                        </a:rPr>
                        <a:t>49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Me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2674541414"/>
                  </a:ext>
                </a:extLst>
              </a:tr>
              <a:tr h="150729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m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Z (</a:t>
                      </a:r>
                      <a:r>
                        <a:rPr lang="hu-HU" sz="800" b="1" dirty="0">
                          <a:effectLst/>
                        </a:rPr>
                        <a:t>50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OEt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115155347"/>
                  </a:ext>
                </a:extLst>
              </a:tr>
              <a:tr h="150729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t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B (</a:t>
                      </a:r>
                      <a:r>
                        <a:rPr lang="hu-HU" sz="800" b="1" dirty="0">
                          <a:effectLst/>
                        </a:rPr>
                        <a:t>51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OH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392" marR="54392" marT="0" marB="0"/>
                </a:tc>
                <a:extLst>
                  <a:ext uri="{0D108BD9-81ED-4DB2-BD59-A6C34878D82A}">
                    <a16:rowId xmlns:a16="http://schemas.microsoft.com/office/drawing/2014/main" val="2487946864"/>
                  </a:ext>
                </a:extLst>
              </a:tr>
            </a:tbl>
          </a:graphicData>
        </a:graphic>
      </p:graphicFrame>
      <p:graphicFrame>
        <p:nvGraphicFramePr>
          <p:cNvPr id="31" name="Objektum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8519321"/>
              </p:ext>
            </p:extLst>
          </p:nvPr>
        </p:nvGraphicFramePr>
        <p:xfrm>
          <a:off x="3749782" y="5609843"/>
          <a:ext cx="584200" cy="703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" name="CS ChemDraw Drawing" r:id="rId29" imgW="1006851" imgH="1157989" progId="ChemDraw.Document.6.0">
                  <p:embed/>
                </p:oleObj>
              </mc:Choice>
              <mc:Fallback>
                <p:oleObj name="CS ChemDraw Drawing" r:id="rId29" imgW="1006851" imgH="1157989" progId="ChemDraw.Document.6.0">
                  <p:embed/>
                  <p:pic>
                    <p:nvPicPr>
                      <p:cNvPr id="47" name="Objektum 4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49782" y="5609843"/>
                        <a:ext cx="584200" cy="703262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Táblázat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89562339"/>
              </p:ext>
            </p:extLst>
          </p:nvPr>
        </p:nvGraphicFramePr>
        <p:xfrm>
          <a:off x="3207436" y="6323761"/>
          <a:ext cx="1866321" cy="1704912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856671">
                  <a:extLst>
                    <a:ext uri="{9D8B030D-6E8A-4147-A177-3AD203B41FA5}">
                      <a16:colId xmlns:a16="http://schemas.microsoft.com/office/drawing/2014/main" val="1506312071"/>
                    </a:ext>
                  </a:extLst>
                </a:gridCol>
                <a:gridCol w="317500">
                  <a:extLst>
                    <a:ext uri="{9D8B030D-6E8A-4147-A177-3AD203B41FA5}">
                      <a16:colId xmlns:a16="http://schemas.microsoft.com/office/drawing/2014/main" val="3593029016"/>
                    </a:ext>
                  </a:extLst>
                </a:gridCol>
                <a:gridCol w="292100">
                  <a:extLst>
                    <a:ext uri="{9D8B030D-6E8A-4147-A177-3AD203B41FA5}">
                      <a16:colId xmlns:a16="http://schemas.microsoft.com/office/drawing/2014/main" val="2607851036"/>
                    </a:ext>
                  </a:extLst>
                </a:gridCol>
                <a:gridCol w="400050">
                  <a:extLst>
                    <a:ext uri="{9D8B030D-6E8A-4147-A177-3AD203B41FA5}">
                      <a16:colId xmlns:a16="http://schemas.microsoft.com/office/drawing/2014/main" val="2688769154"/>
                    </a:ext>
                  </a:extLst>
                </a:gridCol>
              </a:tblGrid>
              <a:tr h="142076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 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1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2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b="1" dirty="0">
                          <a:effectLst/>
                        </a:rPr>
                        <a:t>R</a:t>
                      </a:r>
                      <a:r>
                        <a:rPr lang="hu-HU" sz="800" b="1" baseline="-25000" dirty="0">
                          <a:effectLst/>
                        </a:rPr>
                        <a:t>3</a:t>
                      </a:r>
                      <a:endParaRPr lang="hu-HU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extLst>
                  <a:ext uri="{0D108BD9-81ED-4DB2-BD59-A6C34878D82A}">
                    <a16:rowId xmlns:a16="http://schemas.microsoft.com/office/drawing/2014/main" val="1111779943"/>
                  </a:ext>
                </a:extLst>
              </a:tr>
              <a:tr h="142076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d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A (</a:t>
                      </a:r>
                      <a:r>
                        <a:rPr lang="hu-HU" sz="800" b="1" dirty="0">
                          <a:effectLst/>
                        </a:rPr>
                        <a:t>52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=O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extLst>
                  <a:ext uri="{0D108BD9-81ED-4DB2-BD59-A6C34878D82A}">
                    <a16:rowId xmlns:a16="http://schemas.microsoft.com/office/drawing/2014/main" val="3181144309"/>
                  </a:ext>
                </a:extLst>
              </a:tr>
              <a:tr h="142076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d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B (</a:t>
                      </a:r>
                      <a:r>
                        <a:rPr lang="hu-HU" sz="800" b="1" dirty="0">
                          <a:effectLst/>
                        </a:rPr>
                        <a:t>53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extLst>
                  <a:ext uri="{0D108BD9-81ED-4DB2-BD59-A6C34878D82A}">
                    <a16:rowId xmlns:a16="http://schemas.microsoft.com/office/drawing/2014/main" val="1208874844"/>
                  </a:ext>
                </a:extLst>
              </a:tr>
              <a:tr h="142076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d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C (</a:t>
                      </a:r>
                      <a:r>
                        <a:rPr lang="hu-HU" sz="800" b="1" dirty="0">
                          <a:effectLst/>
                        </a:rPr>
                        <a:t>54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OAc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extLst>
                  <a:ext uri="{0D108BD9-81ED-4DB2-BD59-A6C34878D82A}">
                    <a16:rowId xmlns:a16="http://schemas.microsoft.com/office/drawing/2014/main" val="1918802594"/>
                  </a:ext>
                </a:extLst>
              </a:tr>
              <a:tr h="142076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s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IV (</a:t>
                      </a:r>
                      <a:r>
                        <a:rPr lang="hu-HU" sz="800" b="1" dirty="0">
                          <a:effectLst/>
                        </a:rPr>
                        <a:t>55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=O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extLst>
                  <a:ext uri="{0D108BD9-81ED-4DB2-BD59-A6C34878D82A}">
                    <a16:rowId xmlns:a16="http://schemas.microsoft.com/office/drawing/2014/main" val="3622104871"/>
                  </a:ext>
                </a:extLst>
              </a:tr>
              <a:tr h="142076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s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IX (</a:t>
                      </a:r>
                      <a:r>
                        <a:rPr lang="hu-HU" sz="800" b="1" dirty="0">
                          <a:effectLst/>
                        </a:rPr>
                        <a:t>56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=O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extLst>
                  <a:ext uri="{0D108BD9-81ED-4DB2-BD59-A6C34878D82A}">
                    <a16:rowId xmlns:a16="http://schemas.microsoft.com/office/drawing/2014/main" val="3052631334"/>
                  </a:ext>
                </a:extLst>
              </a:tr>
              <a:tr h="142076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s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X (</a:t>
                      </a:r>
                      <a:r>
                        <a:rPr lang="hu-HU" sz="800" b="1" dirty="0">
                          <a:effectLst/>
                        </a:rPr>
                        <a:t>57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=O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extLst>
                  <a:ext uri="{0D108BD9-81ED-4DB2-BD59-A6C34878D82A}">
                    <a16:rowId xmlns:a16="http://schemas.microsoft.com/office/drawing/2014/main" val="130434245"/>
                  </a:ext>
                </a:extLst>
              </a:tr>
              <a:tr h="142076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s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XI (</a:t>
                      </a:r>
                      <a:r>
                        <a:rPr lang="hu-HU" sz="800" b="1" dirty="0">
                          <a:effectLst/>
                        </a:rPr>
                        <a:t>58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extLst>
                  <a:ext uri="{0D108BD9-81ED-4DB2-BD59-A6C34878D82A}">
                    <a16:rowId xmlns:a16="http://schemas.microsoft.com/office/drawing/2014/main" val="3827619299"/>
                  </a:ext>
                </a:extLst>
              </a:tr>
              <a:tr h="142076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s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XII (</a:t>
                      </a:r>
                      <a:r>
                        <a:rPr lang="hu-HU" sz="800" b="1" dirty="0">
                          <a:effectLst/>
                        </a:rPr>
                        <a:t>59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=O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extLst>
                  <a:ext uri="{0D108BD9-81ED-4DB2-BD59-A6C34878D82A}">
                    <a16:rowId xmlns:a16="http://schemas.microsoft.com/office/drawing/2014/main" val="3437102102"/>
                  </a:ext>
                </a:extLst>
              </a:tr>
              <a:tr h="142076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s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XIII (</a:t>
                      </a:r>
                      <a:r>
                        <a:rPr lang="hu-HU" sz="800" b="1" dirty="0">
                          <a:effectLst/>
                        </a:rPr>
                        <a:t>60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=O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extLst>
                  <a:ext uri="{0D108BD9-81ED-4DB2-BD59-A6C34878D82A}">
                    <a16:rowId xmlns:a16="http://schemas.microsoft.com/office/drawing/2014/main" val="219220670"/>
                  </a:ext>
                </a:extLst>
              </a:tr>
              <a:tr h="142076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s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XIV (</a:t>
                      </a:r>
                      <a:r>
                        <a:rPr lang="hu-HU" sz="800" b="1" dirty="0">
                          <a:effectLst/>
                        </a:rPr>
                        <a:t>61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α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extLst>
                  <a:ext uri="{0D108BD9-81ED-4DB2-BD59-A6C34878D82A}">
                    <a16:rowId xmlns:a16="http://schemas.microsoft.com/office/drawing/2014/main" val="3478152792"/>
                  </a:ext>
                </a:extLst>
              </a:tr>
              <a:tr h="142076">
                <a:tc>
                  <a:txBody>
                    <a:bodyPr/>
                    <a:lstStyle/>
                    <a:p>
                      <a:pPr indent="0"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 err="1" smtClean="0">
                          <a:effectLst/>
                        </a:rPr>
                        <a:t>spirasine</a:t>
                      </a:r>
                      <a:r>
                        <a:rPr lang="hu-HU" sz="800" dirty="0" smtClean="0">
                          <a:effectLst/>
                        </a:rPr>
                        <a:t> </a:t>
                      </a:r>
                      <a:r>
                        <a:rPr lang="hu-HU" sz="800" dirty="0">
                          <a:effectLst/>
                        </a:rPr>
                        <a:t>XV (</a:t>
                      </a:r>
                      <a:r>
                        <a:rPr lang="hu-HU" sz="800" b="1" dirty="0">
                          <a:effectLst/>
                        </a:rPr>
                        <a:t>62</a:t>
                      </a:r>
                      <a:r>
                        <a:rPr lang="hu-HU" sz="800" dirty="0">
                          <a:effectLst/>
                        </a:rPr>
                        <a:t>)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β-O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>
                          <a:effectLst/>
                        </a:rPr>
                        <a:t>H</a:t>
                      </a:r>
                      <a:endParaRPr lang="hu-HU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hu-HU" sz="800" dirty="0">
                          <a:effectLst/>
                        </a:rPr>
                        <a:t>β-OH</a:t>
                      </a:r>
                      <a:endParaRPr lang="hu-HU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326" marR="45326" marT="0" marB="0"/>
                </a:tc>
                <a:extLst>
                  <a:ext uri="{0D108BD9-81ED-4DB2-BD59-A6C34878D82A}">
                    <a16:rowId xmlns:a16="http://schemas.microsoft.com/office/drawing/2014/main" val="2086537252"/>
                  </a:ext>
                </a:extLst>
              </a:tr>
            </a:tbl>
          </a:graphicData>
        </a:graphic>
      </p:graphicFrame>
      <p:graphicFrame>
        <p:nvGraphicFramePr>
          <p:cNvPr id="33" name="Objektum 3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4826414"/>
              </p:ext>
            </p:extLst>
          </p:nvPr>
        </p:nvGraphicFramePr>
        <p:xfrm>
          <a:off x="5614599" y="5620963"/>
          <a:ext cx="650875" cy="635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0" name="CS ChemDraw Drawing" r:id="rId31" imgW="1107461" imgH="1069754" progId="ChemDraw.Document.6.0">
                  <p:embed/>
                </p:oleObj>
              </mc:Choice>
              <mc:Fallback>
                <p:oleObj name="CS ChemDraw Drawing" r:id="rId31" imgW="1107461" imgH="1069754" progId="ChemDraw.Document.6.0">
                  <p:embed/>
                  <p:pic>
                    <p:nvPicPr>
                      <p:cNvPr id="50" name="Objektum 4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614599" y="5620963"/>
                        <a:ext cx="650875" cy="6350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" name="Téglalap 33"/>
          <p:cNvSpPr/>
          <p:nvPr/>
        </p:nvSpPr>
        <p:spPr>
          <a:xfrm>
            <a:off x="5206016" y="6266619"/>
            <a:ext cx="155523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Aft>
                <a:spcPts val="0"/>
              </a:spcAft>
            </a:pPr>
            <a:r>
              <a:rPr lang="hu-HU" sz="800" dirty="0" err="1" smtClean="0">
                <a:ea typeface="Calibri" panose="020F0502020204030204" pitchFamily="34" charset="0"/>
                <a:cs typeface="Times New Roman" panose="02020603050405020304" pitchFamily="18" charset="0"/>
              </a:rPr>
              <a:t>spiraqine</a:t>
            </a:r>
            <a:r>
              <a:rPr lang="hu-HU" sz="8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hu-HU" sz="800" b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63</a:t>
            </a:r>
            <a:r>
              <a:rPr lang="hu-HU" sz="8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) (R=H)</a:t>
            </a:r>
          </a:p>
          <a:p>
            <a:pPr algn="ctr">
              <a:spcAft>
                <a:spcPts val="0"/>
              </a:spcAft>
            </a:pPr>
            <a:r>
              <a:rPr lang="hu-HU" sz="8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6-hydroxyspiraquine (</a:t>
            </a:r>
            <a:r>
              <a:rPr lang="hu-HU" sz="800" b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64</a:t>
            </a:r>
            <a:r>
              <a:rPr lang="hu-HU" sz="8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) (R=OH)</a:t>
            </a:r>
            <a:endParaRPr lang="hu-HU" sz="8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35" name="Objektum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7069932"/>
              </p:ext>
            </p:extLst>
          </p:nvPr>
        </p:nvGraphicFramePr>
        <p:xfrm>
          <a:off x="5599517" y="6570776"/>
          <a:ext cx="681038" cy="636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" name="CS ChemDraw Drawing" r:id="rId33" imgW="1168356" imgH="1072393" progId="ChemDraw.Document.6.0">
                  <p:embed/>
                </p:oleObj>
              </mc:Choice>
              <mc:Fallback>
                <p:oleObj name="CS ChemDraw Drawing" r:id="rId33" imgW="1168356" imgH="1072393" progId="ChemDraw.Document.6.0">
                  <p:embed/>
                  <p:pic>
                    <p:nvPicPr>
                      <p:cNvPr id="53" name="Objektum 5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599517" y="6570776"/>
                        <a:ext cx="681038" cy="63658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Téglalap 35"/>
          <p:cNvSpPr/>
          <p:nvPr/>
        </p:nvSpPr>
        <p:spPr>
          <a:xfrm>
            <a:off x="5677862" y="7172967"/>
            <a:ext cx="65434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Aft>
                <a:spcPts val="0"/>
              </a:spcAft>
            </a:pPr>
            <a:r>
              <a:rPr lang="hu-HU" sz="800" dirty="0" err="1" smtClean="0">
                <a:ea typeface="Calibri" panose="020F0502020204030204" pitchFamily="34" charset="0"/>
                <a:cs typeface="Times New Roman" panose="02020603050405020304" pitchFamily="18" charset="0"/>
              </a:rPr>
              <a:t>spirein</a:t>
            </a:r>
            <a:r>
              <a:rPr lang="hu-HU" sz="8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hu-HU" sz="800" b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65</a:t>
            </a:r>
            <a:r>
              <a:rPr lang="hu-HU" sz="800" dirty="0"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665896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597</Words>
  <Application>Microsoft Office PowerPoint</Application>
  <PresentationFormat>A4 (210x297 mm)</PresentationFormat>
  <Paragraphs>301</Paragraphs>
  <Slides>1</Slides>
  <Notes>0</Notes>
  <HiddenSlides>0</HiddenSlides>
  <MMClips>0</MMClips>
  <ScaleCrop>false</ScaleCrop>
  <HeadingPairs>
    <vt:vector size="8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Beágyazott OLE kiszolgálók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-téma</vt:lpstr>
      <vt:lpstr>CS ChemDraw Drawing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Kiss Tivadar</dc:creator>
  <cp:lastModifiedBy>Kiss Tivadar</cp:lastModifiedBy>
  <cp:revision>1</cp:revision>
  <dcterms:created xsi:type="dcterms:W3CDTF">2017-07-17T13:33:34Z</dcterms:created>
  <dcterms:modified xsi:type="dcterms:W3CDTF">2017-07-17T13:39:40Z</dcterms:modified>
</cp:coreProperties>
</file>